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F52E2A-C72A-45E0-AE0C-9ECB5A779259}" v="8" dt="2024-10-10T07:12:57.5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>
        <p:scale>
          <a:sx n="50" d="100"/>
          <a:sy n="50" d="100"/>
        </p:scale>
        <p:origin x="2200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4FF52E2A-C72A-45E0-AE0C-9ECB5A779259}"/>
    <pc:docChg chg="addSld delSld modSld">
      <pc:chgData name="赤堀　ゆきこ" userId="bbfeda90-9ade-440e-995a-5a1e8cff3baf" providerId="ADAL" clId="{4FF52E2A-C72A-45E0-AE0C-9ECB5A779259}" dt="2024-10-10T07:16:57.763" v="20" actId="20577"/>
      <pc:docMkLst>
        <pc:docMk/>
      </pc:docMkLst>
      <pc:sldChg chg="add del">
        <pc:chgData name="赤堀　ゆきこ" userId="bbfeda90-9ade-440e-995a-5a1e8cff3baf" providerId="ADAL" clId="{4FF52E2A-C72A-45E0-AE0C-9ECB5A779259}" dt="2024-10-10T06:48:54.628" v="7" actId="47"/>
        <pc:sldMkLst>
          <pc:docMk/>
          <pc:sldMk cId="2071845089" sldId="256"/>
        </pc:sldMkLst>
      </pc:sldChg>
      <pc:sldChg chg="add del">
        <pc:chgData name="赤堀　ゆきこ" userId="bbfeda90-9ade-440e-995a-5a1e8cff3baf" providerId="ADAL" clId="{4FF52E2A-C72A-45E0-AE0C-9ECB5A779259}" dt="2024-10-10T06:49:05.649" v="9" actId="47"/>
        <pc:sldMkLst>
          <pc:docMk/>
          <pc:sldMk cId="1509033053" sldId="257"/>
        </pc:sldMkLst>
      </pc:sldChg>
      <pc:sldChg chg="add del">
        <pc:chgData name="赤堀　ゆきこ" userId="bbfeda90-9ade-440e-995a-5a1e8cff3baf" providerId="ADAL" clId="{4FF52E2A-C72A-45E0-AE0C-9ECB5A779259}" dt="2024-10-10T07:12:58.978" v="15" actId="47"/>
        <pc:sldMkLst>
          <pc:docMk/>
          <pc:sldMk cId="2888254083" sldId="258"/>
        </pc:sldMkLst>
      </pc:sldChg>
      <pc:sldChg chg="modSp add del mod">
        <pc:chgData name="赤堀　ゆきこ" userId="bbfeda90-9ade-440e-995a-5a1e8cff3baf" providerId="ADAL" clId="{4FF52E2A-C72A-45E0-AE0C-9ECB5A779259}" dt="2024-10-10T07:16:57.763" v="20" actId="20577"/>
        <pc:sldMkLst>
          <pc:docMk/>
          <pc:sldMk cId="2741535718" sldId="259"/>
        </pc:sldMkLst>
        <pc:graphicFrameChg chg="modGraphic">
          <ac:chgData name="赤堀　ゆきこ" userId="bbfeda90-9ade-440e-995a-5a1e8cff3baf" providerId="ADAL" clId="{4FF52E2A-C72A-45E0-AE0C-9ECB5A779259}" dt="2024-10-10T07:16:57.763" v="20" actId="20577"/>
          <ac:graphicFrameMkLst>
            <pc:docMk/>
            <pc:sldMk cId="2741535718" sldId="259"/>
            <ac:graphicFrameMk id="2" creationId="{F75C753D-EE2B-662A-3BFC-0B36A5BBB22C}"/>
          </ac:graphicFrameMkLst>
        </pc:graphicFrameChg>
      </pc:sldChg>
      <pc:sldChg chg="del">
        <pc:chgData name="赤堀　ゆきこ" userId="bbfeda90-9ade-440e-995a-5a1e8cff3baf" providerId="ADAL" clId="{4FF52E2A-C72A-45E0-AE0C-9ECB5A779259}" dt="2024-10-10T06:47:43.415" v="1" actId="47"/>
        <pc:sldMkLst>
          <pc:docMk/>
          <pc:sldMk cId="3223437358" sldId="261"/>
        </pc:sldMkLst>
      </pc:sldChg>
      <pc:sldChg chg="add del">
        <pc:chgData name="赤堀　ゆきこ" userId="bbfeda90-9ade-440e-995a-5a1e8cff3baf" providerId="ADAL" clId="{4FF52E2A-C72A-45E0-AE0C-9ECB5A779259}" dt="2024-10-10T06:47:55.364" v="3" actId="47"/>
        <pc:sldMkLst>
          <pc:docMk/>
          <pc:sldMk cId="13072062" sldId="263"/>
        </pc:sldMkLst>
      </pc:sldChg>
      <pc:sldChg chg="add del">
        <pc:chgData name="赤堀　ゆきこ" userId="bbfeda90-9ade-440e-995a-5a1e8cff3baf" providerId="ADAL" clId="{4FF52E2A-C72A-45E0-AE0C-9ECB5A779259}" dt="2024-10-10T06:48:15.765" v="5" actId="47"/>
        <pc:sldMkLst>
          <pc:docMk/>
          <pc:sldMk cId="1150512429" sldId="26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F75C753D-EE2B-662A-3BFC-0B36A5BBB2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5189392"/>
              </p:ext>
            </p:extLst>
          </p:nvPr>
        </p:nvGraphicFramePr>
        <p:xfrm>
          <a:off x="202361" y="3752489"/>
          <a:ext cx="6453278" cy="132299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607041">
                  <a:extLst>
                    <a:ext uri="{9D8B030D-6E8A-4147-A177-3AD203B41FA5}">
                      <a16:colId xmlns:a16="http://schemas.microsoft.com/office/drawing/2014/main" val="2514198119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4109472279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875737280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1178209468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575383281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2348840572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3911439969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1011850310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2727193811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2991022382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3277710246"/>
                    </a:ext>
                  </a:extLst>
                </a:gridCol>
                <a:gridCol w="440567">
                  <a:extLst>
                    <a:ext uri="{9D8B030D-6E8A-4147-A177-3AD203B41FA5}">
                      <a16:colId xmlns:a16="http://schemas.microsoft.com/office/drawing/2014/main" val="226230795"/>
                    </a:ext>
                  </a:extLst>
                </a:gridCol>
              </a:tblGrid>
              <a:tr h="134618">
                <a:tc rowSpan="2"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 gridSpan="11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y zone (mm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0433001"/>
                  </a:ext>
                </a:extLst>
              </a:tr>
              <a:tr h="1162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7128731"/>
                  </a:ext>
                </a:extLst>
              </a:tr>
              <a:tr h="123604"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aureus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CC 433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3974434"/>
                  </a:ext>
                </a:extLst>
              </a:tr>
              <a:tr h="12360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extLst>
                  <a:ext uri="{0D108BD9-81ED-4DB2-BD59-A6C34878D82A}">
                    <a16:rowId xmlns:a16="http://schemas.microsoft.com/office/drawing/2014/main" val="232249295"/>
                  </a:ext>
                </a:extLst>
              </a:tr>
              <a:tr h="12360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6140279"/>
                  </a:ext>
                </a:extLst>
              </a:tr>
              <a:tr h="1162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36666713"/>
                  </a:ext>
                </a:extLst>
              </a:tr>
              <a:tr h="1162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19" marR="6119" marT="6119" marB="0" anchor="ctr"/>
                </a:tc>
                <a:extLst>
                  <a:ext uri="{0D108BD9-81ED-4DB2-BD59-A6C34878D82A}">
                    <a16:rowId xmlns:a16="http://schemas.microsoft.com/office/drawing/2014/main" val="4189314807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8475C33-2825-0A86-DD36-8F5840AA66DC}"/>
              </a:ext>
            </a:extLst>
          </p:cNvPr>
          <p:cNvSpPr txBox="1"/>
          <p:nvPr/>
        </p:nvSpPr>
        <p:spPr>
          <a:xfrm>
            <a:off x="813777" y="3048586"/>
            <a:ext cx="16979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4 dataset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dataset of Fig. 4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8D5C270-5564-2F4F-9D48-4E9FDA370276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1535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9</Words>
  <Application>Microsoft Office PowerPoint</Application>
  <PresentationFormat>A4 210 x 297 mm</PresentationFormat>
  <Paragraphs>7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ゆきこ 赤堀</cp:lastModifiedBy>
  <cp:revision>3</cp:revision>
  <dcterms:created xsi:type="dcterms:W3CDTF">2024-10-10T06:46:11Z</dcterms:created>
  <dcterms:modified xsi:type="dcterms:W3CDTF">2024-10-11T11:54:20Z</dcterms:modified>
</cp:coreProperties>
</file>